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368972-60AC-4BF2-B839-4AF31FFB4D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36CBCB-1572-4DED-A92B-9F75835D2C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F17FB-B3C8-4006-9E44-923FBA538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9F3F02-3621-4447-98B0-936F77D5B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0548BA-1CAD-49A0-B088-C5D29A351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102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46D22C-6663-48B9-B42B-69AD5A18E6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5A1AFD-1A0C-4940-90AE-6AE60E9FB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3D1CB4-B66B-47DE-99DC-79592524F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EB28AD-4592-4C9F-B666-9DB8D83C2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A7E02E-B21F-4773-AD2B-234925011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657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D40A3E-92F7-46E4-B005-92C86C034A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AC9914-7681-4D9A-96C7-70A0EE66A4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DF3B8B-A5AC-4C5F-A2D6-6F852402A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0FFDCD-7A37-4D2A-A7EC-ED0209049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A46A94-72E6-4AAC-9240-BEB98F2B9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67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7CFD58-7C07-45FB-BFAA-F09CF93C7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54FCD7-3D34-41B2-A6CD-E7DB15D52E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DB3C36-4DBE-4E8D-8E9B-AA0578854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A451B7-D1D1-464E-819D-2157A200A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E4303D-94AB-426A-BBAF-091D5698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921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C9AC99-08F2-49DA-A31B-A814B363F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A91A4E-D8AF-4AAF-AA4C-C1C7BF5B41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CB9022-DFC4-49A2-84E7-C1F47D9B2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1DC383-3F19-4D52-82C6-649223D8D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FFDBA0-A4B6-42D2-B405-B12EDA7CC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274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4D92D8-EE3D-4EDA-B567-70285D7793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A7CA41-6FFF-4705-8900-87B47E8D85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DC0762-1AFA-456A-AD28-D64E25E016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F8978E-945B-41B3-BA9D-0B745BC41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89BD3B-D29C-43E0-8F2A-6265F89E8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CB78F5-750B-4A25-9881-158A84355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481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AD141F-66FA-442C-A684-B5E931AA94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16CA8B-87AF-4DDF-B55B-A9714C755B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B8BC0A-A6C5-4868-8536-54B7023884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12F4F7-6E52-4086-A077-1A31D34A00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59A465-43E7-414D-8D90-FF205D7137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DD4E63-95A0-4B11-B107-A88B3D8DA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30225C-A5E8-41A0-AFAD-C38805A4D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0D7512-6038-4971-BD63-9E41FA783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887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0CC6ED-CFFA-411F-B828-E560F3D386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10F1EB-F672-4C9C-92EB-FA1A4C4B5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A38902-A5DE-46E1-AE8E-00A667B37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0EEE45-8609-495A-90B0-BFA0D57E4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493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3E916B2-3EEF-4437-8EF7-356852024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DF70D6-C9CB-44B2-B84E-ACC557FD8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DA4078-D016-4E94-B142-BC30C32CF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833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96698-0E07-44F1-A7C5-E728F50453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C1BAD2-A843-4722-92F1-3B37E74C03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68164F-4BB2-42BF-90DF-143EEB837A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8027AF-6500-484A-A628-67CFE9B0D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FBF38A-1637-4F68-9CA5-BE269B074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4BECA6-9CB6-43B4-A2F0-353B7B0D9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169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5BD022-1E4C-4D64-A06D-3080BBF7D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EFE4AA-3876-4464-A612-8E5257B196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953881-DEEB-4FF4-9A43-044F5C35D1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B494AD-CA27-4F17-86AE-F3FD7BA3B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635647-7211-4498-B78E-E853E8D2B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259E91-5F96-4937-A3B4-C6B50580A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540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46A1D8-94C3-439D-B1A6-93422D446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23CB0F-B72B-4F7B-8D12-ED71E1B48A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0A79F2-CF7F-4899-BDD8-EF85A9E525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4DB58-DDE8-4C05-9859-3BB9C8F7D370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7B0D23-DF92-4C16-AC18-35349FA596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D56F88-EB33-4796-BF58-442CE10E56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5A956-CAC7-4BB3-8414-24ABBCE577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85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5085419-6547-4B2A-8C0D-817965FCA9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4" r="1060"/>
          <a:stretch/>
        </p:blipFill>
        <p:spPr>
          <a:xfrm>
            <a:off x="27104" y="1856232"/>
            <a:ext cx="12137792" cy="299008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A92E91A-FD7C-3C09-8EF1-BDAF59B14BB3}"/>
              </a:ext>
            </a:extLst>
          </p:cNvPr>
          <p:cNvSpPr txBox="1"/>
          <p:nvPr/>
        </p:nvSpPr>
        <p:spPr>
          <a:xfrm>
            <a:off x="-1" y="5281588"/>
            <a:ext cx="121377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S7: Classified image of low samples, where most of the kernel pixels are non-symptomatic (as shown in green color) and a fraction are symptomatic (as shown in purple </a:t>
            </a:r>
            <a:r>
              <a:rPr lang="en-US"/>
              <a:t>color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2329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8C0679CE3F1146B99428810CFFD1A5" ma:contentTypeVersion="13" ma:contentTypeDescription="Create a new document." ma:contentTypeScope="" ma:versionID="87104e6739588b1d33bffce79ec9ef76">
  <xsd:schema xmlns:xsd="http://www.w3.org/2001/XMLSchema" xmlns:xs="http://www.w3.org/2001/XMLSchema" xmlns:p="http://schemas.microsoft.com/office/2006/metadata/properties" xmlns:ns3="9435e4ad-f246-4104-a637-66c8bc3c99a7" xmlns:ns4="64ecab17-5948-449f-a717-624ba6338b70" targetNamespace="http://schemas.microsoft.com/office/2006/metadata/properties" ma:root="true" ma:fieldsID="0405a160c580c868c8adfe7b1b3dd395" ns3:_="" ns4:_="">
    <xsd:import namespace="9435e4ad-f246-4104-a637-66c8bc3c99a7"/>
    <xsd:import namespace="64ecab17-5948-449f-a717-624ba6338b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435e4ad-f246-4104-a637-66c8bc3c99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4ecab17-5948-449f-a717-624ba6338b70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D096FD0-B3A3-471A-B212-0CC8CAE7684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E3976DC-4D10-4727-B9DB-20B976F5F5F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435e4ad-f246-4104-a637-66c8bc3c99a7"/>
    <ds:schemaRef ds:uri="64ecab17-5948-449f-a717-624ba6338b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333AB9C-C073-4707-B3C0-74C0045FBD5A}">
  <ds:schemaRefs>
    <ds:schemaRef ds:uri="http://purl.org/dc/terms/"/>
    <ds:schemaRef ds:uri="http://purl.org/dc/dcmitype/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9435e4ad-f246-4104-a637-66c8bc3c99a7"/>
    <ds:schemaRef ds:uri="64ecab17-5948-449f-a717-624ba6338b70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Kshitiz</dc:creator>
  <cp:lastModifiedBy>song li</cp:lastModifiedBy>
  <cp:revision>2</cp:revision>
  <dcterms:created xsi:type="dcterms:W3CDTF">2022-12-22T16:22:17Z</dcterms:created>
  <dcterms:modified xsi:type="dcterms:W3CDTF">2023-03-28T00:20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8C0679CE3F1146B99428810CFFD1A5</vt:lpwstr>
  </property>
</Properties>
</file>